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57" r:id="rId2"/>
    <p:sldId id="260" r:id="rId3"/>
    <p:sldId id="261" r:id="rId4"/>
    <p:sldId id="258" r:id="rId5"/>
    <p:sldId id="259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05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5F9D43-01BC-4B41-9419-49E9D8631D79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B00E30-6CC2-4E6C-8FBA-3416E1625D6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098126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52C0AE-31B0-4472-8FBB-D00CE80CF2C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6763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16853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4012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99542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72872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22201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32901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30715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6342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98919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98065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10862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746BBC-3674-4450-A069-E848542CE38A}" type="datetimeFigureOut">
              <a:rPr lang="en-CA" smtClean="0"/>
              <a:t>2021-09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BF85BE-38DA-480B-ACE3-AF649E118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42855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330792" y="511358"/>
            <a:ext cx="6214387" cy="6637609"/>
            <a:chOff x="523297" y="318853"/>
            <a:chExt cx="5864631" cy="6637609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AA23E42-4CC1-415C-B349-9359713B1C05}"/>
                </a:ext>
              </a:extLst>
            </p:cNvPr>
            <p:cNvSpPr txBox="1"/>
            <p:nvPr/>
          </p:nvSpPr>
          <p:spPr>
            <a:xfrm>
              <a:off x="1055509" y="804797"/>
              <a:ext cx="533241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mmunofluorescent detection of GFAP expression (red, 63x) in selected GBM cell isolates of different proteomic clusters. </a:t>
              </a: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523297" y="318853"/>
              <a:ext cx="200776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S1.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CA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9" name="Group 38"/>
            <p:cNvGrpSpPr/>
            <p:nvPr/>
          </p:nvGrpSpPr>
          <p:grpSpPr>
            <a:xfrm>
              <a:off x="1138082" y="1467561"/>
              <a:ext cx="4560432" cy="5488901"/>
              <a:chOff x="767118" y="643534"/>
              <a:chExt cx="4560432" cy="5488901"/>
            </a:xfrm>
          </p:grpSpPr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C452049A-2620-4BDD-B4BA-CE9765D8A5B0}"/>
                  </a:ext>
                </a:extLst>
              </p:cNvPr>
              <p:cNvSpPr txBox="1"/>
              <p:nvPr/>
            </p:nvSpPr>
            <p:spPr>
              <a:xfrm>
                <a:off x="767118" y="4348856"/>
                <a:ext cx="83012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GBM-146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7EF9566E-9D60-4810-B7D5-FB286A8DBAD3}"/>
                  </a:ext>
                </a:extLst>
              </p:cNvPr>
              <p:cNvSpPr txBox="1"/>
              <p:nvPr/>
            </p:nvSpPr>
            <p:spPr>
              <a:xfrm>
                <a:off x="769106" y="5519583"/>
                <a:ext cx="82814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GBM-220</a:t>
                </a: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5F2F0AE1-D7C6-41B0-9D06-CB65CDEDE409}"/>
                  </a:ext>
                </a:extLst>
              </p:cNvPr>
              <p:cNvSpPr txBox="1"/>
              <p:nvPr/>
            </p:nvSpPr>
            <p:spPr>
              <a:xfrm>
                <a:off x="774269" y="1324015"/>
                <a:ext cx="82297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GBM-224</a:t>
                </a:r>
              </a:p>
            </p:txBody>
          </p:sp>
          <p:pic>
            <p:nvPicPr>
              <p:cNvPr id="6" name="Picture 3" descr="H:\2019\Z2\Jan 24-19\Imgaes\PBS-146_GFAP_X63-3-Image Export-15\PBS-146_GFAP_X63-3-Image Export-15_c1-2.jpg">
                <a:extLst>
                  <a:ext uri="{FF2B5EF4-FFF2-40B4-BE49-F238E27FC236}">
                    <a16:creationId xmlns:a16="http://schemas.microsoft.com/office/drawing/2014/main" id="{7C87C68C-A5DD-4EBD-B5AD-2A7A6F81AA0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80443" y="4066011"/>
                <a:ext cx="1352369" cy="100829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" name="Picture 4" descr="H:\2019\Z2\Jan 24-19\Imgaes\PBS-146_mIgG_X63-1-Image Export-16\PBS-146_mIgG_X63-1-Image Export-16_c1-2.jpg">
                <a:extLst>
                  <a:ext uri="{FF2B5EF4-FFF2-40B4-BE49-F238E27FC236}">
                    <a16:creationId xmlns:a16="http://schemas.microsoft.com/office/drawing/2014/main" id="{111B2D49-9354-4D6F-ADCB-1BA86471557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64565" y="4061005"/>
                <a:ext cx="1352369" cy="101330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" name="Picture 6" descr="H:\2019\Z2\Jan 24-19\Imgaes\PBS-220_GFAP_X63-2-Image Export-23\PBS-220_GFAP_X63-2-Image Export-23_c1-2.jpg">
                <a:extLst>
                  <a:ext uri="{FF2B5EF4-FFF2-40B4-BE49-F238E27FC236}">
                    <a16:creationId xmlns:a16="http://schemas.microsoft.com/office/drawing/2014/main" id="{285AA75D-FB89-4E18-A659-736A4A51342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80444" y="5119133"/>
                <a:ext cx="1352369" cy="101330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" name="Picture 7" descr="H:\2019\Z2\Jan 24-19\Imgaes\PBS-220_mIgG_X63-1-Image Export-25\PBS-220_mIgG_X63-1-Image Export-25_c1-2.jpg">
                <a:extLst>
                  <a:ext uri="{FF2B5EF4-FFF2-40B4-BE49-F238E27FC236}">
                    <a16:creationId xmlns:a16="http://schemas.microsoft.com/office/drawing/2014/main" id="{515FA455-D2E0-4733-A4C6-0F97AB05FB3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64564" y="5119133"/>
                <a:ext cx="1352369" cy="101330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2" name="Picture 9" descr="H:\2019\Z2\Jan 24-19\Imgaes\PBS-224_GFAP_X63-1-Image Export-31\PBS-224_GFAP_X63-1-Image Export-31_c1-2.jpg">
                <a:extLst>
                  <a:ext uri="{FF2B5EF4-FFF2-40B4-BE49-F238E27FC236}">
                    <a16:creationId xmlns:a16="http://schemas.microsoft.com/office/drawing/2014/main" id="{F81A9CEB-F14D-45E3-9FAB-3313311A382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80442" y="921846"/>
                <a:ext cx="1352369" cy="101330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" name="Picture 10" descr="H:\2019\Z2\Jan 24-19\Imgaes\PBS-224_mIgG_X63-1-Image Export-34\PBS-224_mIgG_X63-1-Image Export-34_c1-2.jpg">
                <a:extLst>
                  <a:ext uri="{FF2B5EF4-FFF2-40B4-BE49-F238E27FC236}">
                    <a16:creationId xmlns:a16="http://schemas.microsoft.com/office/drawing/2014/main" id="{988C823F-36CA-4E0E-A714-F213961EE85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64563" y="921846"/>
                <a:ext cx="1352369" cy="101330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51354E3E-7F8C-47C1-B6A1-5D7B9F26C7E7}"/>
                  </a:ext>
                </a:extLst>
              </p:cNvPr>
              <p:cNvSpPr txBox="1"/>
              <p:nvPr/>
            </p:nvSpPr>
            <p:spPr>
              <a:xfrm>
                <a:off x="1593162" y="644150"/>
                <a:ext cx="13396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GFAP 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F7DB5898-B7C8-4D79-B02C-14B2F0CFF154}"/>
                  </a:ext>
                </a:extLst>
              </p:cNvPr>
              <p:cNvSpPr txBox="1"/>
              <p:nvPr/>
            </p:nvSpPr>
            <p:spPr>
              <a:xfrm>
                <a:off x="2971796" y="643534"/>
                <a:ext cx="13262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Mouse IgG</a:t>
                </a:r>
              </a:p>
            </p:txBody>
          </p:sp>
          <p:pic>
            <p:nvPicPr>
              <p:cNvPr id="17" name="Picture 3" descr="H:\2019\Z2\Jan 24-19\Imgaes\PBS-29_GFAP_x63-1-Image Export-04\PBS-29_GFAP_x63-1-Image Export-04_c1-2.jpg">
                <a:extLst>
                  <a:ext uri="{FF2B5EF4-FFF2-40B4-BE49-F238E27FC236}">
                    <a16:creationId xmlns:a16="http://schemas.microsoft.com/office/drawing/2014/main" id="{88320282-643E-4906-B729-E0C7A3A81CC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80442" y="1964628"/>
                <a:ext cx="1352370" cy="101330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BF66EBC-B8EE-4468-8BFF-1F5CADC4A438}"/>
                  </a:ext>
                </a:extLst>
              </p:cNvPr>
              <p:cNvSpPr txBox="1"/>
              <p:nvPr/>
            </p:nvSpPr>
            <p:spPr>
              <a:xfrm>
                <a:off x="772279" y="2455853"/>
                <a:ext cx="8249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GBM-29</a:t>
                </a:r>
              </a:p>
            </p:txBody>
          </p:sp>
          <p:pic>
            <p:nvPicPr>
              <p:cNvPr id="20" name="Picture 5" descr="H:\2019\Z2\Jan 24-19\Imgaes\PBS-35_GFAP_X63-3-Image Export-06\PBS-35_GFAP_X63-3-Image Export-06_c1-2.jpg">
                <a:extLst>
                  <a:ext uri="{FF2B5EF4-FFF2-40B4-BE49-F238E27FC236}">
                    <a16:creationId xmlns:a16="http://schemas.microsoft.com/office/drawing/2014/main" id="{1C5EAF80-97BB-4E3F-B57C-3C23797A817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80442" y="3015531"/>
                <a:ext cx="1352370" cy="101330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B5F30ECE-955E-4B9E-A91A-DB0C44BE6A85}"/>
                  </a:ext>
                </a:extLst>
              </p:cNvPr>
              <p:cNvSpPr txBox="1"/>
              <p:nvPr/>
            </p:nvSpPr>
            <p:spPr>
              <a:xfrm>
                <a:off x="769109" y="3360963"/>
                <a:ext cx="8281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GBM-35</a:t>
                </a:r>
              </a:p>
            </p:txBody>
          </p:sp>
          <p:pic>
            <p:nvPicPr>
              <p:cNvPr id="22" name="Picture 14" descr="\\MEDSERVER1\medusers$\umthanas\My Documents\My Pictures\Aug30-18\PBS-29\JPEG\PBS-29_mIgG_x63-3-Image Export-09\PBS-29_mIgG_x63-3-Image Export-09_c1+2.jpg">
                <a:extLst>
                  <a:ext uri="{FF2B5EF4-FFF2-40B4-BE49-F238E27FC236}">
                    <a16:creationId xmlns:a16="http://schemas.microsoft.com/office/drawing/2014/main" id="{1DE838A7-C96D-4637-9B53-4C81E103EE71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64562" y="1964628"/>
                <a:ext cx="1352370" cy="101330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4" name="Picture 6" descr="H:\2019\Z2\Jan 24-19\Imgaes\PBS-35_mIgG_X63-2-Image Export-08\PBS-35_mIgG_X63-2-Image Export-08_c1-2.jpg">
                <a:extLst>
                  <a:ext uri="{FF2B5EF4-FFF2-40B4-BE49-F238E27FC236}">
                    <a16:creationId xmlns:a16="http://schemas.microsoft.com/office/drawing/2014/main" id="{DAE46CCB-A144-46EE-9754-8E3087B15F0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64560" y="3009577"/>
                <a:ext cx="1352370" cy="101925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425FBF58-DACE-47B2-8E00-385D46EED834}"/>
                  </a:ext>
                </a:extLst>
              </p:cNvPr>
              <p:cNvSpPr txBox="1"/>
              <p:nvPr/>
            </p:nvSpPr>
            <p:spPr>
              <a:xfrm>
                <a:off x="4302287" y="1248155"/>
                <a:ext cx="91096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u="sng">
                    <a:latin typeface="Arial" panose="020B0604020202020204" pitchFamily="34" charset="0"/>
                    <a:cs typeface="Arial" panose="020B0604020202020204" pitchFamily="34" charset="0"/>
                  </a:rPr>
                  <a:t>Cluster 2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D78BCDA0-4449-409F-97BD-075A5C5FEC6F}"/>
                  </a:ext>
                </a:extLst>
              </p:cNvPr>
              <p:cNvSpPr txBox="1"/>
              <p:nvPr/>
            </p:nvSpPr>
            <p:spPr>
              <a:xfrm>
                <a:off x="4416587" y="3397281"/>
                <a:ext cx="91096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u="sng">
                    <a:latin typeface="Arial" panose="020B0604020202020204" pitchFamily="34" charset="0"/>
                    <a:cs typeface="Arial" panose="020B0604020202020204" pitchFamily="34" charset="0"/>
                  </a:rPr>
                  <a:t>Cluster 3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80F083F3-E688-4B8A-A062-271497774E63}"/>
                  </a:ext>
                </a:extLst>
              </p:cNvPr>
              <p:cNvSpPr txBox="1"/>
              <p:nvPr/>
            </p:nvSpPr>
            <p:spPr>
              <a:xfrm>
                <a:off x="4302287" y="5447100"/>
                <a:ext cx="91096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u="sng">
                    <a:latin typeface="Arial" panose="020B0604020202020204" pitchFamily="34" charset="0"/>
                    <a:cs typeface="Arial" panose="020B0604020202020204" pitchFamily="34" charset="0"/>
                  </a:rPr>
                  <a:t>Cluster 4</a:t>
                </a:r>
              </a:p>
            </p:txBody>
          </p:sp>
          <p:cxnSp>
            <p:nvCxnSpPr>
              <p:cNvPr id="41" name="Straight Connector 40"/>
              <p:cNvCxnSpPr/>
              <p:nvPr/>
            </p:nvCxnSpPr>
            <p:spPr>
              <a:xfrm>
                <a:off x="4421569" y="1998159"/>
                <a:ext cx="0" cy="3006138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644406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68718" y="51345"/>
            <a:ext cx="6818315" cy="8860116"/>
            <a:chOff x="68718" y="51345"/>
            <a:chExt cx="6818315" cy="8860116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50" r="15625"/>
            <a:stretch/>
          </p:blipFill>
          <p:spPr>
            <a:xfrm>
              <a:off x="132520" y="456097"/>
              <a:ext cx="6606087" cy="237511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DA9DDCA-0F5C-4A88-8FA4-5DAC63A72801}"/>
                </a:ext>
              </a:extLst>
            </p:cNvPr>
            <p:cNvSpPr txBox="1"/>
            <p:nvPr/>
          </p:nvSpPr>
          <p:spPr>
            <a:xfrm>
              <a:off x="68718" y="61485"/>
              <a:ext cx="22355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S2.</a:t>
              </a:r>
              <a:endParaRPr lang="en-US" sz="12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397095" y="51345"/>
              <a:ext cx="4489938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roups of biological process terms for GBM proteomic cluster 1</a:t>
              </a: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93" r="21696"/>
            <a:stretch/>
          </p:blipFill>
          <p:spPr>
            <a:xfrm>
              <a:off x="1156278" y="3592157"/>
              <a:ext cx="4558569" cy="23774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TextBox 6"/>
            <p:cNvSpPr txBox="1"/>
            <p:nvPr/>
          </p:nvSpPr>
          <p:spPr>
            <a:xfrm>
              <a:off x="713315" y="3214098"/>
              <a:ext cx="4428499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lecular function terms enriched in GBM proteomic cluster 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B071EBB-0040-4173-A76A-F15489E33B30}"/>
                </a:ext>
              </a:extLst>
            </p:cNvPr>
            <p:cNvSpPr txBox="1"/>
            <p:nvPr/>
          </p:nvSpPr>
          <p:spPr>
            <a:xfrm>
              <a:off x="161553" y="3214097"/>
              <a:ext cx="4083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4"/>
            <a:srcRect l="10913" r="10430" b="8857"/>
            <a:stretch/>
          </p:blipFill>
          <p:spPr>
            <a:xfrm>
              <a:off x="68718" y="6716901"/>
              <a:ext cx="6728151" cy="21945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B071EBB-0040-4173-A76A-F15489E33B30}"/>
                </a:ext>
              </a:extLst>
            </p:cNvPr>
            <p:cNvSpPr txBox="1"/>
            <p:nvPr/>
          </p:nvSpPr>
          <p:spPr>
            <a:xfrm>
              <a:off x="135482" y="6318726"/>
              <a:ext cx="4472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59089" y="6318725"/>
              <a:ext cx="380072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Cluster 1 enriched group of </a:t>
              </a:r>
              <a:r>
                <a:rPr lang="en-US" sz="1200" err="1">
                  <a:latin typeface="Arial" panose="020B0604020202020204" pitchFamily="34" charset="0"/>
                  <a:cs typeface="Arial" panose="020B0604020202020204" pitchFamily="34" charset="0"/>
                </a:rPr>
                <a:t>Reactome</a:t>
              </a:r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 pathways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F9A709C1-AC7A-4D29-B17B-6C3150B11578}"/>
              </a:ext>
            </a:extLst>
          </p:cNvPr>
          <p:cNvSpPr txBox="1"/>
          <p:nvPr/>
        </p:nvSpPr>
        <p:spPr>
          <a:xfrm>
            <a:off x="2175613" y="51344"/>
            <a:ext cx="4429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U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62692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1635" y="1201295"/>
            <a:ext cx="6542314" cy="5454718"/>
            <a:chOff x="161635" y="1201295"/>
            <a:chExt cx="6542314" cy="5454718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2"/>
            <a:srcRect l="28689" t="3243" r="13689" b="8101"/>
            <a:stretch/>
          </p:blipFill>
          <p:spPr>
            <a:xfrm>
              <a:off x="161635" y="1602162"/>
              <a:ext cx="6542314" cy="505385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DA9DDCA-0F5C-4A88-8FA4-5DAC63A72801}"/>
                </a:ext>
              </a:extLst>
            </p:cNvPr>
            <p:cNvSpPr txBox="1"/>
            <p:nvPr/>
          </p:nvSpPr>
          <p:spPr>
            <a:xfrm>
              <a:off x="161635" y="1201295"/>
              <a:ext cx="65423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S2.               D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luster 1 enriched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Reactome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pathway networ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802548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9115" y="362577"/>
            <a:ext cx="6612673" cy="7540171"/>
            <a:chOff x="89115" y="362577"/>
            <a:chExt cx="6612673" cy="7540171"/>
          </a:xfrm>
        </p:grpSpPr>
        <p:sp>
          <p:nvSpPr>
            <p:cNvPr id="9" name="Rectangle 8"/>
            <p:cNvSpPr/>
            <p:nvPr/>
          </p:nvSpPr>
          <p:spPr>
            <a:xfrm>
              <a:off x="89115" y="362577"/>
              <a:ext cx="6612673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S3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ene Ontology analysis. Pie charts depicting GO terms for biological processes, cellular components and molecular functions in (A) cluster 2 and (B) cluster 3. </a:t>
              </a:r>
              <a:endParaRPr lang="en-US" sz="12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B071EBB-0040-4173-A76A-F15489E33B30}"/>
                </a:ext>
              </a:extLst>
            </p:cNvPr>
            <p:cNvSpPr txBox="1"/>
            <p:nvPr/>
          </p:nvSpPr>
          <p:spPr>
            <a:xfrm>
              <a:off x="89115" y="1007426"/>
              <a:ext cx="5241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400" b="1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  <a:endParaRPr 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B071EBB-0040-4173-A76A-F15489E33B30}"/>
                </a:ext>
              </a:extLst>
            </p:cNvPr>
            <p:cNvSpPr txBox="1"/>
            <p:nvPr/>
          </p:nvSpPr>
          <p:spPr>
            <a:xfrm>
              <a:off x="89115" y="4731851"/>
              <a:ext cx="5241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400" b="1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  <a:endParaRPr 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43" r="12678"/>
            <a:stretch/>
          </p:blipFill>
          <p:spPr>
            <a:xfrm>
              <a:off x="186886" y="1397832"/>
              <a:ext cx="6417129" cy="26827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36" r="19196"/>
            <a:stretch/>
          </p:blipFill>
          <p:spPr>
            <a:xfrm>
              <a:off x="186885" y="5146612"/>
              <a:ext cx="6417129" cy="275613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186885" y="1389529"/>
              <a:ext cx="2768539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luster 2: Biological process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86884" y="5147156"/>
              <a:ext cx="2768539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Cluster 3: Biological proces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926646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-29093" y="375965"/>
            <a:ext cx="7488109" cy="3897436"/>
            <a:chOff x="-29093" y="375965"/>
            <a:chExt cx="7488109" cy="3897436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B071EBB-0040-4173-A76A-F15489E33B30}"/>
                </a:ext>
              </a:extLst>
            </p:cNvPr>
            <p:cNvSpPr txBox="1"/>
            <p:nvPr/>
          </p:nvSpPr>
          <p:spPr>
            <a:xfrm>
              <a:off x="462854" y="901206"/>
              <a:ext cx="5241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400" b="1"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  <a:endParaRPr 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07" r="18036"/>
            <a:stretch/>
          </p:blipFill>
          <p:spPr>
            <a:xfrm>
              <a:off x="724908" y="1346814"/>
              <a:ext cx="5882526" cy="29265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" name="Rectangle 15"/>
            <p:cNvSpPr/>
            <p:nvPr/>
          </p:nvSpPr>
          <p:spPr>
            <a:xfrm>
              <a:off x="-29093" y="383660"/>
              <a:ext cx="213827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S3. </a:t>
              </a:r>
              <a:endParaRPr lang="en-US" sz="12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038634" y="375965"/>
              <a:ext cx="5420382" cy="2923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Molecular functions associated with proteomic cluster 2 and 3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24908" y="1341060"/>
              <a:ext cx="2768539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Cluster 2: Molecular function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61568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17</TotalTime>
  <Words>156</Words>
  <Application>Microsoft Office PowerPoint</Application>
  <PresentationFormat>On-screen Show (4:3)</PresentationFormat>
  <Paragraphs>30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Klonisch</dc:creator>
  <cp:lastModifiedBy>MDPI-03</cp:lastModifiedBy>
  <cp:revision>12</cp:revision>
  <dcterms:created xsi:type="dcterms:W3CDTF">2021-04-21T15:27:43Z</dcterms:created>
  <dcterms:modified xsi:type="dcterms:W3CDTF">2021-09-03T12:44:48Z</dcterms:modified>
</cp:coreProperties>
</file>